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68" r:id="rId3"/>
    <p:sldId id="266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5" autoAdjust="0"/>
    <p:restoredTop sz="94660"/>
  </p:normalViewPr>
  <p:slideViewPr>
    <p:cSldViewPr snapToGrid="0">
      <p:cViewPr varScale="1">
        <p:scale>
          <a:sx n="79" d="100"/>
          <a:sy n="79" d="100"/>
        </p:scale>
        <p:origin x="54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4613D5-F6D5-40BD-A869-E6BCF8D2F45B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6609B3-C133-4516-8E0A-CE10B89A9F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518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57250" y="1143000"/>
            <a:ext cx="51435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7F3906-60E3-45E7-B5C3-5E50CDA31BB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3449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57250" y="1143000"/>
            <a:ext cx="51435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7F3906-60E3-45E7-B5C3-5E50CDA31BB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681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5B9DE-96CC-02F0-97A6-DFEDA6B622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1C8131-A349-B153-1996-0E481D17AA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48D433-FD4E-20C1-DD29-B43372793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FC4099-0F9A-8176-492A-A9C053465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90BB96-93C5-7242-EEDF-042E9C192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77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78CD8-5648-EA4A-F370-BED21D4DA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F6AE61-C7A6-5482-EB96-5662D29C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2AA45B-7021-FBF9-1E23-0A1C7A5BF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66E38-FC19-D173-FBF9-26708A0FD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EC64EE-0B68-6216-B539-618FD7BF8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11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5662AC-57AF-ACA8-488C-95F7EE4CA8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9BED7D-A30B-8753-8BDC-48CA9EC42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D5436F-29B4-E16E-0896-4CDE2D9A5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E2AB57-76BF-4474-278F-9861320B6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9EE2C-6041-F6E1-0926-B0AF4B904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777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6BA1E2-EDCE-E58D-F469-84913056F3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008BBE-2044-6D40-865C-C9222A0D9F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61888-9EAE-EA7B-ABBD-28CEC61BB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25A2BD-6483-1B11-26C9-D2D62922E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8B50DB-F644-15CF-A3EC-9D318BA67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228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70F47F-E587-D702-ECC5-47F6226B2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77BE54-9392-7289-677F-5BA8F6CD1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AF8EC-01FA-5599-FBF3-258990540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FE4C3-F969-9769-BE95-6E4F07178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30DC2A-93AC-E548-DD8A-2505F1010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657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405D3-B79F-29C0-E7EB-4C42B5430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5AFBEA-F47F-F187-B75C-C8D5D4C4B6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742F81-C1FF-FE30-F6AB-61A308CCBA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41541E-0A20-CA96-C79B-B54642011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9C1849-EC03-F8E0-82A0-C8AE1A038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725CB4-3FC3-920C-B277-E273844FE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5B65A-AE85-C4AC-16EE-035E9B81A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C1B1E-C697-BA66-7B6F-592D655FE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5E4D6B-62DC-AA5F-74B1-AB8B1C1ED4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7A4A8D-8043-16CA-FBC9-9A1A7B736E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D3FF2F-7B5E-17B7-6CF7-5CD4BE30CC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E273B0-E23D-86FB-9D9D-907493B5C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65F50C-295A-8607-D88B-961960AA1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74E4CA-47C1-8B11-1232-225F1EC69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126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8717D-6F3E-B769-FF28-062AF011C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17A685-BA15-397E-61D6-E19F2EB50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A71EC2-5F73-0C4D-DB55-B2AB18A6D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DA0726-01AE-07A6-3E25-42D19C152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81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3410-2E1B-10A4-9469-A73AFF18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5373E3-27C6-AA3E-EE7A-9456865B7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A8320D-A9CC-6A99-C31F-C7CFC958A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587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A6243-8555-4D7A-6394-611DF6041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E25C7A-F9CA-5F2D-2EF4-F052B9376F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5EE5DE-0E6A-FC2B-9812-E3F9BF63EB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D62F0D-637F-D5F8-80A9-41CF3A775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7B8FCC-667B-99B2-F4BE-381C5DE86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9230DC-FAC7-999E-D6DD-F3588335C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731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00D51E-D379-6CFA-452E-1BBB81DA3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266F05-C747-D80E-2C8E-929DC48DAF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0E02DD-7A3F-9D15-F4A9-142B727386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F1A28A-7A50-783F-233B-2F20E2F15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EBDEC9-7851-985B-2699-8D7DD0A62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70DC0E-BF1D-AF45-85AF-49C7FBCCA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388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D32880-0624-A009-4080-321CA7707C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F7231A-49DD-D549-8A2C-01F36DBB1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A673D-9F50-050C-E16B-FA0F8E2462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549476-8BB7-4463-BADD-9EB0CDB618C7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C95202-71A4-7610-AFA4-973348C2A8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0E110-C16F-5084-40F2-0A5A156D6B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B642D-7451-46E1-91AE-698F0FE75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006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3F27A7-42E6-11BE-D9E9-95551E1D552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500" dirty="0"/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3477473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3091395-74ED-8089-4DF4-1C7E644229C6}"/>
              </a:ext>
            </a:extLst>
          </p:cNvPr>
          <p:cNvSpPr txBox="1"/>
          <p:nvPr/>
        </p:nvSpPr>
        <p:spPr>
          <a:xfrm>
            <a:off x="1352917" y="213966"/>
            <a:ext cx="8814399" cy="481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4" dirty="0"/>
              <a:t>Supplemental Figure 1: Cumulative Positivity on Ag-RDT and PCR by Day Post Symptom Onset and Day Past Exposure by Vaccination Status </a:t>
            </a:r>
          </a:p>
        </p:txBody>
      </p:sp>
      <p:pic>
        <p:nvPicPr>
          <p:cNvPr id="4" name="Picture 3" descr="A picture containing timeline&#10;&#10;Description automatically generated">
            <a:extLst>
              <a:ext uri="{FF2B5EF4-FFF2-40B4-BE49-F238E27FC236}">
                <a16:creationId xmlns:a16="http://schemas.microsoft.com/office/drawing/2014/main" id="{E5F765D0-493A-D381-4F6A-08C6CF8E03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60" y="833901"/>
            <a:ext cx="3297694" cy="2355496"/>
          </a:xfrm>
          <a:prstGeom prst="rect">
            <a:avLst/>
          </a:prstGeom>
        </p:spPr>
      </p:pic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B375BC05-394C-F759-AAFC-0CA2855D39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59" y="3578664"/>
            <a:ext cx="3550303" cy="253593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50DDB3A-FEB2-403F-2EF7-841ACC7FBB25}"/>
              </a:ext>
            </a:extLst>
          </p:cNvPr>
          <p:cNvSpPr txBox="1"/>
          <p:nvPr/>
        </p:nvSpPr>
        <p:spPr>
          <a:xfrm>
            <a:off x="490459" y="680013"/>
            <a:ext cx="381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9B6867-6D7A-4F8F-085A-F141ABF6C0B1}"/>
              </a:ext>
            </a:extLst>
          </p:cNvPr>
          <p:cNvSpPr txBox="1"/>
          <p:nvPr/>
        </p:nvSpPr>
        <p:spPr>
          <a:xfrm>
            <a:off x="381000" y="3509501"/>
            <a:ext cx="381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d. 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0F0E21BA-94CB-E5A6-8D65-F50B68B096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63429" y="833901"/>
            <a:ext cx="3448428" cy="23554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EA607F2-F7F0-9D48-BF94-8C674FA1438B}"/>
              </a:ext>
            </a:extLst>
          </p:cNvPr>
          <p:cNvSpPr txBox="1"/>
          <p:nvPr/>
        </p:nvSpPr>
        <p:spPr>
          <a:xfrm>
            <a:off x="7992559" y="749176"/>
            <a:ext cx="381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c. </a:t>
            </a:r>
          </a:p>
        </p:txBody>
      </p:sp>
      <p:pic>
        <p:nvPicPr>
          <p:cNvPr id="3076" name="Picture 4">
            <a:extLst>
              <a:ext uri="{FF2B5EF4-FFF2-40B4-BE49-F238E27FC236}">
                <a16:creationId xmlns:a16="http://schemas.microsoft.com/office/drawing/2014/main" id="{8D9EABE1-053C-551A-4F7A-8741A01DC8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0330" y="833901"/>
            <a:ext cx="3448428" cy="23553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EDD7A6F-368F-3121-CEA7-91F2C8AE9FFF}"/>
              </a:ext>
            </a:extLst>
          </p:cNvPr>
          <p:cNvSpPr txBox="1"/>
          <p:nvPr/>
        </p:nvSpPr>
        <p:spPr>
          <a:xfrm>
            <a:off x="4000159" y="749176"/>
            <a:ext cx="381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b. </a:t>
            </a:r>
          </a:p>
        </p:txBody>
      </p:sp>
      <p:pic>
        <p:nvPicPr>
          <p:cNvPr id="3078" name="Picture 6">
            <a:extLst>
              <a:ext uri="{FF2B5EF4-FFF2-40B4-BE49-F238E27FC236}">
                <a16:creationId xmlns:a16="http://schemas.microsoft.com/office/drawing/2014/main" id="{1C8CAA87-43F2-FB01-C671-53AFEA69FB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0330" y="3578804"/>
            <a:ext cx="3550303" cy="2535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800FE23-8E5D-98FB-0B05-E3D6C63E4C7E}"/>
              </a:ext>
            </a:extLst>
          </p:cNvPr>
          <p:cNvSpPr txBox="1"/>
          <p:nvPr/>
        </p:nvSpPr>
        <p:spPr>
          <a:xfrm>
            <a:off x="4062989" y="3514846"/>
            <a:ext cx="3181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e.</a:t>
            </a:r>
          </a:p>
        </p:txBody>
      </p:sp>
    </p:spTree>
    <p:extLst>
      <p:ext uri="{BB962C8B-B14F-4D97-AF65-F5344CB8AC3E}">
        <p14:creationId xmlns:p14="http://schemas.microsoft.com/office/powerpoint/2010/main" val="34923798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41D69597-6A6D-C3E7-4669-8AEFADB8F4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656" y="1955760"/>
            <a:ext cx="4495273" cy="3210908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E5729855-9C21-B8A5-7310-6EBC9D2836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2" y="1955760"/>
            <a:ext cx="4495273" cy="32109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974907C-EEDB-A324-2212-645F019E94D3}"/>
              </a:ext>
            </a:extLst>
          </p:cNvPr>
          <p:cNvSpPr txBox="1"/>
          <p:nvPr/>
        </p:nvSpPr>
        <p:spPr>
          <a:xfrm>
            <a:off x="1367729" y="1063460"/>
            <a:ext cx="8814399" cy="286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4" dirty="0"/>
              <a:t>Supplemental Figure 2: Positivity on Ag-RDT and PCR by Day Post Exposure by Symptom Status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08E81DB-AB9F-46F7-B277-748CE2138171}"/>
              </a:ext>
            </a:extLst>
          </p:cNvPr>
          <p:cNvSpPr txBox="1"/>
          <p:nvPr/>
        </p:nvSpPr>
        <p:spPr>
          <a:xfrm>
            <a:off x="2238209" y="1541890"/>
            <a:ext cx="2838008" cy="286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64" dirty="0"/>
              <a:t>Asymptomati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652461-D6BB-CE5F-C26F-14B2D81B9407}"/>
              </a:ext>
            </a:extLst>
          </p:cNvPr>
          <p:cNvSpPr txBox="1"/>
          <p:nvPr/>
        </p:nvSpPr>
        <p:spPr>
          <a:xfrm>
            <a:off x="7026916" y="1541890"/>
            <a:ext cx="2838008" cy="286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64" dirty="0"/>
              <a:t>Symptomatic</a:t>
            </a:r>
          </a:p>
        </p:txBody>
      </p:sp>
    </p:spTree>
    <p:extLst>
      <p:ext uri="{BB962C8B-B14F-4D97-AF65-F5344CB8AC3E}">
        <p14:creationId xmlns:p14="http://schemas.microsoft.com/office/powerpoint/2010/main" val="3121745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7027BEA8-857B-7EEC-494C-F5D1E70B9A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2286" y="898575"/>
            <a:ext cx="4015084" cy="25383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>
            <a:extLst>
              <a:ext uri="{FF2B5EF4-FFF2-40B4-BE49-F238E27FC236}">
                <a16:creationId xmlns:a16="http://schemas.microsoft.com/office/drawing/2014/main" id="{2B7105F8-1F56-A3A5-91E0-5D327B2C6C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2287" y="3533618"/>
            <a:ext cx="4015084" cy="27528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>
            <a:extLst>
              <a:ext uri="{FF2B5EF4-FFF2-40B4-BE49-F238E27FC236}">
                <a16:creationId xmlns:a16="http://schemas.microsoft.com/office/drawing/2014/main" id="{80FBE5B8-5EB3-8634-14A2-4EC5154C81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4635" y="903480"/>
            <a:ext cx="3966309" cy="22268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>
            <a:extLst>
              <a:ext uri="{FF2B5EF4-FFF2-40B4-BE49-F238E27FC236}">
                <a16:creationId xmlns:a16="http://schemas.microsoft.com/office/drawing/2014/main" id="{C3F8FDA4-D7FC-4B23-6F33-93CA2CF362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4636" y="3533621"/>
            <a:ext cx="3966309" cy="24209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98DF97-7C9F-0EE9-98F4-6F8BA7BE8E46}"/>
              </a:ext>
            </a:extLst>
          </p:cNvPr>
          <p:cNvSpPr txBox="1"/>
          <p:nvPr/>
        </p:nvSpPr>
        <p:spPr>
          <a:xfrm>
            <a:off x="1875971" y="619873"/>
            <a:ext cx="8050238" cy="286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4" dirty="0"/>
              <a:t>Supplemental Figure 3: Distribution of CT values by DPSO and DPE among Vaccinated and Unvaccinated Participants </a:t>
            </a:r>
          </a:p>
        </p:txBody>
      </p:sp>
    </p:spTree>
    <p:extLst>
      <p:ext uri="{BB962C8B-B14F-4D97-AF65-F5344CB8AC3E}">
        <p14:creationId xmlns:p14="http://schemas.microsoft.com/office/powerpoint/2010/main" val="1070198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Widescreen</PresentationFormat>
  <Paragraphs>13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l Figure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Herbert, Carly</dc:creator>
  <cp:lastModifiedBy>Herbert, Carly</cp:lastModifiedBy>
  <cp:revision>1</cp:revision>
  <dcterms:created xsi:type="dcterms:W3CDTF">2023-02-21T14:24:05Z</dcterms:created>
  <dcterms:modified xsi:type="dcterms:W3CDTF">2023-02-21T14:24:34Z</dcterms:modified>
</cp:coreProperties>
</file>